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96" y="2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61C5DB-64C8-4E5A-B539-D11BD87C9E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ACD0AF7-8B12-4186-82BA-A864A0AF45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198F9E-A902-41C7-B898-CDDF5AAE1C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F2937-3A61-4368-8627-FAE6099E501F}" type="datetimeFigureOut">
              <a:rPr lang="en-US" smtClean="0"/>
              <a:t>9/2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6C887E-C244-4735-BD84-E358A79F28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714C03-7B07-402A-98CD-365982642C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E51D3-1A40-48D1-9820-BF14CF66D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4606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F3A4D4-D2E4-49D1-BDEB-3B47A15B46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A4F987E-5E8E-4106-B8C3-BD01800EE1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442E04-D79A-41D1-9335-ED7A0C317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F2937-3A61-4368-8627-FAE6099E501F}" type="datetimeFigureOut">
              <a:rPr lang="en-US" smtClean="0"/>
              <a:t>9/2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B025A5-2673-4510-902C-FB36F34EFE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3C33AC-78F7-46EB-B7C6-9F649E4C71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E51D3-1A40-48D1-9820-BF14CF66D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6709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D05A953-967D-4129-9FCE-DE582F8E7D8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86FB6E-C430-4C70-977A-ED032E0257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E6BC44-0A95-46E8-8860-E46F3D619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F2937-3A61-4368-8627-FAE6099E501F}" type="datetimeFigureOut">
              <a:rPr lang="en-US" smtClean="0"/>
              <a:t>9/2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7A0BD5-8169-417A-82EA-5CE1D66EFF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FBFF68-2E62-43F0-92BA-326D90632F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E51D3-1A40-48D1-9820-BF14CF66D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2575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B92DBA-0A0E-4448-8BA9-F8D5694656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207B47-119E-4184-95F2-B2341DFC93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576848-692D-44AD-81B2-C19F47A0B5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F2937-3A61-4368-8627-FAE6099E501F}" type="datetimeFigureOut">
              <a:rPr lang="en-US" smtClean="0"/>
              <a:t>9/2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F18086-55D7-44F4-8B41-C6D38043CF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BCA770-F878-4387-AD33-EA51B85269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E51D3-1A40-48D1-9820-BF14CF66D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63527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20C445-AEBB-4D54-BE42-B9630DF59D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6AD321-305D-4E3E-931C-E643B0256E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758F18-0BC3-4A29-92E7-F2F59974F9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F2937-3A61-4368-8627-FAE6099E501F}" type="datetimeFigureOut">
              <a:rPr lang="en-US" smtClean="0"/>
              <a:t>9/2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4ECECA-867D-4AC7-9CB2-D1EE94F50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E38288-5861-447E-A7D9-BE76F355FF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E51D3-1A40-48D1-9820-BF14CF66D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9299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7B8E94-5102-4230-9571-BBC0EB9F12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F23246-2157-4CC4-8D65-CD59DC864EB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3C30DC-280C-4DC9-ACC7-7F0E61ED37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70A4B9-F11D-4DAE-ABBD-5B0D2C2FEC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F2937-3A61-4368-8627-FAE6099E501F}" type="datetimeFigureOut">
              <a:rPr lang="en-US" smtClean="0"/>
              <a:t>9/2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9B0441-B25D-4FC9-BE06-5ECFA6D3C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853028-B613-43BF-85F8-A5C96D48E4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E51D3-1A40-48D1-9820-BF14CF66D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36822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6AFC76-0B82-438F-A3F0-11E606D638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98A804-8CC1-4DF6-B360-6FF92FAE02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2F30A4-5F78-4E1D-8D35-C272371ECF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917DE5D-6DD5-4597-900F-2513B88FDE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4F8715F-1954-42A4-B780-7CD9E5237DD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1242D18-678C-4BAC-A35C-663DCA8CC7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F2937-3A61-4368-8627-FAE6099E501F}" type="datetimeFigureOut">
              <a:rPr lang="en-US" smtClean="0"/>
              <a:t>9/27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291A4CB-784D-4356-9F0F-BC06AECF7F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AB41670-0E17-4DC5-AC68-0F5C41A959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E51D3-1A40-48D1-9820-BF14CF66D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5180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D870A7-54D6-4831-ADFF-83FB81F360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1C0C80D-0864-41B9-9390-B366556EA1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F2937-3A61-4368-8627-FAE6099E501F}" type="datetimeFigureOut">
              <a:rPr lang="en-US" smtClean="0"/>
              <a:t>9/27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A39D88D-1AE7-4C21-B1A7-4C9E59265A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C62950B-89F2-42E7-9987-E33078E4BF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E51D3-1A40-48D1-9820-BF14CF66D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136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3CA9A56-E34D-4FBF-ADB3-B5E6245ECD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F2937-3A61-4368-8627-FAE6099E501F}" type="datetimeFigureOut">
              <a:rPr lang="en-US" smtClean="0"/>
              <a:t>9/27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5B2AB83-2851-4F7B-BDD7-4AFCAAC89B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3DB624D-581D-42E7-8D78-1CB2C585B1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E51D3-1A40-48D1-9820-BF14CF66D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824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C4FFBD-C703-41BF-970B-3F5810DB51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E4D0BF-2FC0-456C-98E8-C3116297CE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819151-489E-47DA-A776-04AABFA3A8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12AC12-B3E7-4974-A54B-46507EBC44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F2937-3A61-4368-8627-FAE6099E501F}" type="datetimeFigureOut">
              <a:rPr lang="en-US" smtClean="0"/>
              <a:t>9/2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B91971-ECC4-49F3-9018-68C5AC60B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EE7A67-497D-4338-A59A-F3AAC0713F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E51D3-1A40-48D1-9820-BF14CF66D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039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DB5D17-0FC4-47B0-90E7-40B9774879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B756BD1-1B3F-4D0C-8CA6-5C5F38413C9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19508B6-4F61-4430-BE91-A785F6AD91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073235-3058-4DD3-8635-0A6DC80E84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F2937-3A61-4368-8627-FAE6099E501F}" type="datetimeFigureOut">
              <a:rPr lang="en-US" smtClean="0"/>
              <a:t>9/2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66C4B7-18FD-4563-AF69-792C409D90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1E18C0-528C-41E2-AE0D-699DA6F948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6E51D3-1A40-48D1-9820-BF14CF66D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246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34E0CF6-37E3-48A7-9F70-AB8A2A2D0D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503898-6193-4195-8D86-881E036EDD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D8709F-2C7C-4537-AEE9-289E0136AF6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CF2937-3A61-4368-8627-FAE6099E501F}" type="datetimeFigureOut">
              <a:rPr lang="en-US" smtClean="0"/>
              <a:t>9/2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832E8E-C5EB-4A9A-9DA1-DBE230811CA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B4DDEA-47F1-4FC1-9D7B-597971A49F0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6E51D3-1A40-48D1-9820-BF14CF66D8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664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C435C35-47F0-4F68-BC39-6AC55CB74460}"/>
              </a:ext>
            </a:extLst>
          </p:cNvPr>
          <p:cNvSpPr txBox="1"/>
          <p:nvPr/>
        </p:nvSpPr>
        <p:spPr>
          <a:xfrm>
            <a:off x="4013282" y="644756"/>
            <a:ext cx="448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3 Figure. Multivariate Analysis of Moist Snuff</a:t>
            </a: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860D3748-E7D2-4B18-A400-1F0F2B11779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58288876"/>
              </p:ext>
            </p:extLst>
          </p:nvPr>
        </p:nvGraphicFramePr>
        <p:xfrm>
          <a:off x="4090737" y="5060459"/>
          <a:ext cx="4144131" cy="146494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67281">
                  <a:extLst>
                    <a:ext uri="{9D8B030D-6E8A-4147-A177-3AD203B41FA5}">
                      <a16:colId xmlns:a16="http://schemas.microsoft.com/office/drawing/2014/main" val="378063993"/>
                    </a:ext>
                  </a:extLst>
                </a:gridCol>
                <a:gridCol w="615370">
                  <a:extLst>
                    <a:ext uri="{9D8B030D-6E8A-4147-A177-3AD203B41FA5}">
                      <a16:colId xmlns:a16="http://schemas.microsoft.com/office/drawing/2014/main" val="917306800"/>
                    </a:ext>
                  </a:extLst>
                </a:gridCol>
                <a:gridCol w="615370">
                  <a:extLst>
                    <a:ext uri="{9D8B030D-6E8A-4147-A177-3AD203B41FA5}">
                      <a16:colId xmlns:a16="http://schemas.microsoft.com/office/drawing/2014/main" val="3023808850"/>
                    </a:ext>
                  </a:extLst>
                </a:gridCol>
                <a:gridCol w="615370">
                  <a:extLst>
                    <a:ext uri="{9D8B030D-6E8A-4147-A177-3AD203B41FA5}">
                      <a16:colId xmlns:a16="http://schemas.microsoft.com/office/drawing/2014/main" val="3749793138"/>
                    </a:ext>
                  </a:extLst>
                </a:gridCol>
                <a:gridCol w="615370">
                  <a:extLst>
                    <a:ext uri="{9D8B030D-6E8A-4147-A177-3AD203B41FA5}">
                      <a16:colId xmlns:a16="http://schemas.microsoft.com/office/drawing/2014/main" val="2046973602"/>
                    </a:ext>
                  </a:extLst>
                </a:gridCol>
                <a:gridCol w="615370">
                  <a:extLst>
                    <a:ext uri="{9D8B030D-6E8A-4147-A177-3AD203B41FA5}">
                      <a16:colId xmlns:a16="http://schemas.microsoft.com/office/drawing/2014/main" val="391665287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SNAs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icotin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H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oistur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ree nicotine (%)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9014246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SNAs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0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16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5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30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15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6312223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Nicotin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16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0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16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164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46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0647844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H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055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16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0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225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98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6425725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Moistur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30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164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225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0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293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2986731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ree nicotine (%)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15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46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98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293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1.00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30618132"/>
                  </a:ext>
                </a:extLst>
              </a:tr>
            </a:tbl>
          </a:graphicData>
        </a:graphic>
      </p:graphicFrame>
      <p:grpSp>
        <p:nvGrpSpPr>
          <p:cNvPr id="10" name="Group 9">
            <a:extLst>
              <a:ext uri="{FF2B5EF4-FFF2-40B4-BE49-F238E27FC236}">
                <a16:creationId xmlns:a16="http://schemas.microsoft.com/office/drawing/2014/main" id="{D5D8B2F2-7CDD-4CE1-B35A-ABC212A943B1}"/>
              </a:ext>
            </a:extLst>
          </p:cNvPr>
          <p:cNvGrpSpPr/>
          <p:nvPr/>
        </p:nvGrpSpPr>
        <p:grpSpPr>
          <a:xfrm>
            <a:off x="4090737" y="1014088"/>
            <a:ext cx="4144130" cy="4046371"/>
            <a:chOff x="4090737" y="1014088"/>
            <a:chExt cx="4144130" cy="4046371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55B9A0DF-4A58-47B1-9AF2-708B3416AE5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090737" y="1014088"/>
              <a:ext cx="4144130" cy="4046371"/>
            </a:xfrm>
            <a:prstGeom prst="rect">
              <a:avLst/>
            </a:prstGeom>
          </p:spPr>
        </p:pic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1E761C06-AC55-43B9-9910-80F8C5F35AF6}"/>
                </a:ext>
              </a:extLst>
            </p:cNvPr>
            <p:cNvSpPr/>
            <p:nvPr/>
          </p:nvSpPr>
          <p:spPr>
            <a:xfrm>
              <a:off x="4470238" y="1060102"/>
              <a:ext cx="727404" cy="64663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C48C1CF3-BD6E-4192-A6FC-24F2EEE84F54}"/>
              </a:ext>
            </a:extLst>
          </p:cNvPr>
          <p:cNvSpPr txBox="1"/>
          <p:nvPr/>
        </p:nvSpPr>
        <p:spPr>
          <a:xfrm>
            <a:off x="4411579" y="1198754"/>
            <a:ext cx="1058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TSNAs (NNN + NNK + NNAL)</a:t>
            </a:r>
          </a:p>
        </p:txBody>
      </p:sp>
    </p:spTree>
    <p:extLst>
      <p:ext uri="{BB962C8B-B14F-4D97-AF65-F5344CB8AC3E}">
        <p14:creationId xmlns:p14="http://schemas.microsoft.com/office/powerpoint/2010/main" val="30664848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68</Words>
  <Application>Microsoft Office PowerPoint</Application>
  <PresentationFormat>Widescreen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yx, Robert (CDC/DDNID/NCEH/DLS)</dc:creator>
  <cp:lastModifiedBy>Tyx, Robert (CDC/DDNID/NCEH/DLS)</cp:lastModifiedBy>
  <cp:revision>2</cp:revision>
  <dcterms:created xsi:type="dcterms:W3CDTF">2021-09-27T17:50:08Z</dcterms:created>
  <dcterms:modified xsi:type="dcterms:W3CDTF">2021-09-27T18:02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7b94a7b8-f06c-4dfe-bdcc-9b548fd58c31_Enabled">
    <vt:lpwstr>true</vt:lpwstr>
  </property>
  <property fmtid="{D5CDD505-2E9C-101B-9397-08002B2CF9AE}" pid="3" name="MSIP_Label_7b94a7b8-f06c-4dfe-bdcc-9b548fd58c31_SetDate">
    <vt:lpwstr>2021-09-27T18:01:38Z</vt:lpwstr>
  </property>
  <property fmtid="{D5CDD505-2E9C-101B-9397-08002B2CF9AE}" pid="4" name="MSIP_Label_7b94a7b8-f06c-4dfe-bdcc-9b548fd58c31_Method">
    <vt:lpwstr>Privileged</vt:lpwstr>
  </property>
  <property fmtid="{D5CDD505-2E9C-101B-9397-08002B2CF9AE}" pid="5" name="MSIP_Label_7b94a7b8-f06c-4dfe-bdcc-9b548fd58c31_Name">
    <vt:lpwstr>7b94a7b8-f06c-4dfe-bdcc-9b548fd58c31</vt:lpwstr>
  </property>
  <property fmtid="{D5CDD505-2E9C-101B-9397-08002B2CF9AE}" pid="6" name="MSIP_Label_7b94a7b8-f06c-4dfe-bdcc-9b548fd58c31_SiteId">
    <vt:lpwstr>9ce70869-60db-44fd-abe8-d2767077fc8f</vt:lpwstr>
  </property>
  <property fmtid="{D5CDD505-2E9C-101B-9397-08002B2CF9AE}" pid="7" name="MSIP_Label_7b94a7b8-f06c-4dfe-bdcc-9b548fd58c31_ActionId">
    <vt:lpwstr>391023d4-2478-4bee-a4fd-c2f95cc1aa1b</vt:lpwstr>
  </property>
  <property fmtid="{D5CDD505-2E9C-101B-9397-08002B2CF9AE}" pid="8" name="MSIP_Label_7b94a7b8-f06c-4dfe-bdcc-9b548fd58c31_ContentBits">
    <vt:lpwstr>0</vt:lpwstr>
  </property>
</Properties>
</file>